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A80926-39BB-49F1-A19A-CFD7B93ACCA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FB0AAB-CB86-4616-BBE9-BB7FEBDA9D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A7BB50-5452-4D34-9671-FA6D1AF8963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2322C2-7FF6-41D5-9200-6AF48619159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DA995E-BC95-41EA-8ECA-F44248584D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EBC750-48EC-4D79-8E86-4F29A32E3C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03D96D-C53B-4A74-817A-87BB4B08FD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919569-65D5-4976-830A-AC8F6B3A22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7302F-E092-477B-9ED6-A9F8B08452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783631-D823-472A-816A-2AC53E0587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EEB830-B43D-45A0-A722-A615B68A59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0D2EC4-206B-4BB4-B0D6-AA3D51F26F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3C074F2-A4A9-4726-8BC5-5CE4F614BB6A}" type="slidenum">
              <a:rPr b="0" lang="en-AU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332000" y="692280"/>
          <a:ext cx="6840360" cy="5470560"/>
        </p:xfrm>
        <a:graphic>
          <a:graphicData uri="http://schemas.openxmlformats.org/drawingml/2006/table">
            <a:tbl>
              <a:tblPr/>
              <a:tblGrid>
                <a:gridCol w="225360"/>
                <a:gridCol w="620640"/>
                <a:gridCol w="779400"/>
                <a:gridCol w="1073160"/>
                <a:gridCol w="835200"/>
                <a:gridCol w="834840"/>
                <a:gridCol w="127080"/>
                <a:gridCol w="692280"/>
                <a:gridCol w="790560"/>
                <a:gridCol w="861840"/>
              </a:tblGrid>
              <a:tr h="226800">
                <a:tc gridSpan="3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Internal validit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716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Q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8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Were selection criteria clearly described?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7468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5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2680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Q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8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Were any quality assurance measures for managing and/or collecting data described?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7468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716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Q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7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Were missing data adequately managed?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68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5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2680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Q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5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Was the length of follow-up described?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7468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716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Q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8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Was the version of the reference code systems used described?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7468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680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Q6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8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Was the derivation of coefficients of TRISS or weights of ICISS described?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7468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716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Q7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8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Were the new coefficients or weights internally or externally validated?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7468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6800">
                <a:tc gridSpan="3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External validit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Q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8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Was the description of the study population reported?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7324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Q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7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Was the study conducted using  multi-institutional population?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288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680"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Q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8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50000"/>
                        </a:lnSpc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Was the precision of AUROC, such as standard error, reported?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27160">
                <a:tc gridSpan="8"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*: applicable to the TRISS and ICISS only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360" rIns="3636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360" marR="36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1"/>
          <p:cNvSpPr/>
          <p:nvPr/>
        </p:nvSpPr>
        <p:spPr>
          <a:xfrm>
            <a:off x="1330560" y="124920"/>
            <a:ext cx="32349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uality assessment questionnair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28T02:43:54Z</dcterms:created>
  <dc:creator>Hideo Tohira</dc:creator>
  <dc:description/>
  <dc:language>en-US</dc:language>
  <cp:lastModifiedBy>soba</cp:lastModifiedBy>
  <dcterms:modified xsi:type="dcterms:W3CDTF">2012-09-09T06:12:35Z</dcterms:modified>
  <cp:revision>5</cp:revision>
  <dc:subject/>
  <dc:title>Slide 1</dc:title>
</cp:coreProperties>
</file>